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7" r:id="rId2"/>
  </p:sldIdLst>
  <p:sldSz cx="9144000" cy="5381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575"/>
  </p:normalViewPr>
  <p:slideViewPr>
    <p:cSldViewPr snapToGrid="0">
      <p:cViewPr varScale="1">
        <p:scale>
          <a:sx n="108" d="100"/>
          <a:sy n="108" d="100"/>
        </p:scale>
        <p:origin x="112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80743"/>
            <a:ext cx="6858000" cy="187360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826599"/>
            <a:ext cx="6858000" cy="129931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4029F-C552-7747-A2EF-3A8DE9ED004A}" type="datetimeFigureOut">
              <a:rPr lang="en-DE" smtClean="0"/>
              <a:t>23.12.25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F5E1-7D77-3B44-BBE3-037D40FC52E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46266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4029F-C552-7747-A2EF-3A8DE9ED004A}" type="datetimeFigureOut">
              <a:rPr lang="en-DE" smtClean="0"/>
              <a:t>23.12.25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F5E1-7D77-3B44-BBE3-037D40FC52E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91074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86522"/>
            <a:ext cx="1971675" cy="456067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86522"/>
            <a:ext cx="5800725" cy="456067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4029F-C552-7747-A2EF-3A8DE9ED004A}" type="datetimeFigureOut">
              <a:rPr lang="en-DE" smtClean="0"/>
              <a:t>23.12.25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F5E1-7D77-3B44-BBE3-037D40FC52E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00349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4029F-C552-7747-A2EF-3A8DE9ED004A}" type="datetimeFigureOut">
              <a:rPr lang="en-DE" smtClean="0"/>
              <a:t>23.12.25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F5E1-7D77-3B44-BBE3-037D40FC52E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87877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341670"/>
            <a:ext cx="7886700" cy="2238606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601454"/>
            <a:ext cx="7886700" cy="117723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4029F-C552-7747-A2EF-3A8DE9ED004A}" type="datetimeFigureOut">
              <a:rPr lang="en-DE" smtClean="0"/>
              <a:t>23.12.25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F5E1-7D77-3B44-BBE3-037D40FC52E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54208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432608"/>
            <a:ext cx="3886200" cy="341459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432608"/>
            <a:ext cx="3886200" cy="341459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4029F-C552-7747-A2EF-3A8DE9ED004A}" type="datetimeFigureOut">
              <a:rPr lang="en-DE" smtClean="0"/>
              <a:t>23.12.25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F5E1-7D77-3B44-BBE3-037D40FC52E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30737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86522"/>
            <a:ext cx="7886700" cy="104019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319246"/>
            <a:ext cx="3868340" cy="64654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965788"/>
            <a:ext cx="3868340" cy="289137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319246"/>
            <a:ext cx="3887391" cy="64654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965788"/>
            <a:ext cx="3887391" cy="289137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4029F-C552-7747-A2EF-3A8DE9ED004A}" type="datetimeFigureOut">
              <a:rPr lang="en-DE" smtClean="0"/>
              <a:t>23.12.25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F5E1-7D77-3B44-BBE3-037D40FC52E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175686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4029F-C552-7747-A2EF-3A8DE9ED004A}" type="datetimeFigureOut">
              <a:rPr lang="en-DE" smtClean="0"/>
              <a:t>23.12.25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F5E1-7D77-3B44-BBE3-037D40FC52E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16754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4029F-C552-7747-A2EF-3A8DE9ED004A}" type="datetimeFigureOut">
              <a:rPr lang="en-DE" smtClean="0"/>
              <a:t>23.12.25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F5E1-7D77-3B44-BBE3-037D40FC52E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74461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58775"/>
            <a:ext cx="2949178" cy="125571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74855"/>
            <a:ext cx="4629150" cy="382444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614487"/>
            <a:ext cx="2949178" cy="299103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4029F-C552-7747-A2EF-3A8DE9ED004A}" type="datetimeFigureOut">
              <a:rPr lang="en-DE" smtClean="0"/>
              <a:t>23.12.25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F5E1-7D77-3B44-BBE3-037D40FC52E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79931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58775"/>
            <a:ext cx="2949178" cy="125571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74855"/>
            <a:ext cx="4629150" cy="382444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614487"/>
            <a:ext cx="2949178" cy="299103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4029F-C552-7747-A2EF-3A8DE9ED004A}" type="datetimeFigureOut">
              <a:rPr lang="en-DE" smtClean="0"/>
              <a:t>23.12.25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F5E1-7D77-3B44-BBE3-037D40FC52E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29686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286522"/>
            <a:ext cx="7886700" cy="104019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432608"/>
            <a:ext cx="7886700" cy="34145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4987969"/>
            <a:ext cx="2057400" cy="2865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04029F-C552-7747-A2EF-3A8DE9ED004A}" type="datetimeFigureOut">
              <a:rPr lang="en-DE" smtClean="0"/>
              <a:t>23.12.25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4987969"/>
            <a:ext cx="3086100" cy="2865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4987969"/>
            <a:ext cx="2057400" cy="2865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33F5E1-7D77-3B44-BBE3-037D40FC52E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71142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DD738D3D-6D00-F5D2-34A6-066A5F4D381E}"/>
              </a:ext>
            </a:extLst>
          </p:cNvPr>
          <p:cNvSpPr/>
          <p:nvPr/>
        </p:nvSpPr>
        <p:spPr>
          <a:xfrm>
            <a:off x="1318105" y="125674"/>
            <a:ext cx="4324201" cy="629587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DE" sz="15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all CRISP SCLC cohort (2019 – 2021)</a:t>
            </a:r>
            <a:r>
              <a:rPr lang="en-DE" sz="16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DE" sz="16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748</a:t>
            </a:r>
            <a:endParaRPr lang="en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2835CF7-59E2-1C7C-5E2C-D784D94647D0}"/>
              </a:ext>
            </a:extLst>
          </p:cNvPr>
          <p:cNvSpPr/>
          <p:nvPr/>
        </p:nvSpPr>
        <p:spPr>
          <a:xfrm>
            <a:off x="1318104" y="1552150"/>
            <a:ext cx="4324203" cy="629588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DE" sz="15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ge IV SCLC cohort receiving 1L treatment</a:t>
            </a:r>
          </a:p>
          <a:p>
            <a:pPr algn="ctr"/>
            <a:r>
              <a:rPr lang="en-DE" sz="16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518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1A9FC5C-9CBB-2DFB-2167-07DD0AB2C6BB}"/>
              </a:ext>
            </a:extLst>
          </p:cNvPr>
          <p:cNvSpPr/>
          <p:nvPr/>
        </p:nvSpPr>
        <p:spPr>
          <a:xfrm>
            <a:off x="6175003" y="3588262"/>
            <a:ext cx="2623395" cy="573060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DE" sz="16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3L treatment started</a:t>
            </a:r>
          </a:p>
          <a:p>
            <a:pPr algn="ctr"/>
            <a:r>
              <a:rPr lang="en-DE" sz="16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50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28598ED-7C80-DD06-14E4-9D90AE4F8D21}"/>
              </a:ext>
            </a:extLst>
          </p:cNvPr>
          <p:cNvSpPr/>
          <p:nvPr/>
        </p:nvSpPr>
        <p:spPr>
          <a:xfrm>
            <a:off x="1318105" y="4236213"/>
            <a:ext cx="4324201" cy="677444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DE" sz="15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nal analysis cohort finishing 3L treatment</a:t>
            </a:r>
          </a:p>
          <a:p>
            <a:pPr algn="ctr"/>
            <a:r>
              <a:rPr lang="en-DE" sz="16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82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32E5C5D-3FE2-CCAB-32F0-F9FB1E280BA0}"/>
              </a:ext>
            </a:extLst>
          </p:cNvPr>
          <p:cNvSpPr/>
          <p:nvPr/>
        </p:nvSpPr>
        <p:spPr>
          <a:xfrm>
            <a:off x="6175005" y="855089"/>
            <a:ext cx="2623393" cy="573060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DE" sz="16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ge I – III excluded</a:t>
            </a:r>
          </a:p>
          <a:p>
            <a:pPr algn="ctr"/>
            <a:r>
              <a:rPr lang="en-DE" sz="16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230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4B82E83-DB79-097B-5BF2-EBD37FC8DB97}"/>
              </a:ext>
            </a:extLst>
          </p:cNvPr>
          <p:cNvSpPr/>
          <p:nvPr/>
        </p:nvSpPr>
        <p:spPr>
          <a:xfrm>
            <a:off x="6175003" y="2269237"/>
            <a:ext cx="2623395" cy="573060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DE" sz="16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2L treatment started</a:t>
            </a:r>
          </a:p>
          <a:p>
            <a:pPr algn="ctr"/>
            <a:r>
              <a:rPr lang="en-DE" sz="16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286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733528D-D97E-2BBC-4343-20F47BDDFDDB}"/>
              </a:ext>
            </a:extLst>
          </p:cNvPr>
          <p:cNvSpPr/>
          <p:nvPr/>
        </p:nvSpPr>
        <p:spPr>
          <a:xfrm>
            <a:off x="2422213" y="2939081"/>
            <a:ext cx="2086122" cy="573060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DE" sz="15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L treatment started</a:t>
            </a:r>
          </a:p>
          <a:p>
            <a:pPr algn="ctr"/>
            <a:r>
              <a:rPr lang="en-DE" sz="16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232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1273E4D7-AE2D-1F55-4956-4B344735C834}"/>
              </a:ext>
            </a:extLst>
          </p:cNvPr>
          <p:cNvCxnSpPr>
            <a:cxnSpLocks/>
            <a:stCxn id="4" idx="2"/>
            <a:endCxn id="5" idx="0"/>
          </p:cNvCxnSpPr>
          <p:nvPr/>
        </p:nvCxnSpPr>
        <p:spPr>
          <a:xfrm>
            <a:off x="3480206" y="755261"/>
            <a:ext cx="0" cy="796889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6514992E-6EBB-A766-9239-40E35EB48B17}"/>
              </a:ext>
            </a:extLst>
          </p:cNvPr>
          <p:cNvCxnSpPr>
            <a:cxnSpLocks/>
            <a:stCxn id="5" idx="2"/>
          </p:cNvCxnSpPr>
          <p:nvPr/>
        </p:nvCxnSpPr>
        <p:spPr>
          <a:xfrm flipH="1">
            <a:off x="3472739" y="2181740"/>
            <a:ext cx="7467" cy="748055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BE861539-3FE2-C443-709A-FFC3B231C6EB}"/>
              </a:ext>
            </a:extLst>
          </p:cNvPr>
          <p:cNvCxnSpPr>
            <a:cxnSpLocks/>
          </p:cNvCxnSpPr>
          <p:nvPr/>
        </p:nvCxnSpPr>
        <p:spPr>
          <a:xfrm>
            <a:off x="3465274" y="3513372"/>
            <a:ext cx="7465" cy="72284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F7A2D3A5-CF69-1497-6A81-3CBB04AB918B}"/>
              </a:ext>
            </a:extLst>
          </p:cNvPr>
          <p:cNvCxnSpPr>
            <a:cxnSpLocks/>
          </p:cNvCxnSpPr>
          <p:nvPr/>
        </p:nvCxnSpPr>
        <p:spPr>
          <a:xfrm flipV="1">
            <a:off x="3480203" y="1132737"/>
            <a:ext cx="2694800" cy="935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111C3B72-E176-5C4F-BBE6-37E864E8FA06}"/>
              </a:ext>
            </a:extLst>
          </p:cNvPr>
          <p:cNvCxnSpPr>
            <a:cxnSpLocks/>
          </p:cNvCxnSpPr>
          <p:nvPr/>
        </p:nvCxnSpPr>
        <p:spPr>
          <a:xfrm flipV="1">
            <a:off x="3480201" y="2555767"/>
            <a:ext cx="2694804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81D0D471-E6B6-3CCB-AAB3-84FB178F9987}"/>
              </a:ext>
            </a:extLst>
          </p:cNvPr>
          <p:cNvCxnSpPr>
            <a:cxnSpLocks/>
          </p:cNvCxnSpPr>
          <p:nvPr/>
        </p:nvCxnSpPr>
        <p:spPr>
          <a:xfrm>
            <a:off x="3465274" y="3874792"/>
            <a:ext cx="2694804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5409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85</TotalTime>
  <Words>59</Words>
  <Application>Microsoft Macintosh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x Rost</dc:creator>
  <cp:lastModifiedBy>Max Rost</cp:lastModifiedBy>
  <cp:revision>17</cp:revision>
  <dcterms:created xsi:type="dcterms:W3CDTF">2025-10-16T08:34:23Z</dcterms:created>
  <dcterms:modified xsi:type="dcterms:W3CDTF">2025-12-23T18:20:31Z</dcterms:modified>
</cp:coreProperties>
</file>